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12192000" cy="9144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4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4" d="100"/>
          <a:sy n="84" d="100"/>
        </p:scale>
        <p:origin x="1548" y="150"/>
      </p:cViewPr>
      <p:guideLst>
        <p:guide orient="horz" pos="2849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D:\Documentos-Juan%20Maldonado\Docencia-Posgrados-JGM\MCV-Henao%20Mariana%20Tesis\FinalManuscriptMarianaHenao-November2021\Analisis%20Base%20de%20dato%20Doppler%20Nov092021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D:\Documentos-Juan%20Maldonado\Docencia-Posgrados-JGM\MCV-Henao%20Mariana%20Tesis\FinalManuscriptMarianaHenao-November2021\Analisis%20Base%20de%20dato%20Doppler%20Nov09202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1" i="0" u="none" strike="noStrike" kern="1200" cap="none" spc="5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b="1" dirty="0"/>
              <a:t>D/S values healthy cow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1" i="0" u="none" strike="noStrike" kern="1200" cap="none" spc="5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s-CO"/>
        </a:p>
      </c:txPr>
    </c:title>
    <c:autoTitleDeleted val="0"/>
    <c:plotArea>
      <c:layout>
        <c:manualLayout>
          <c:layoutTarget val="inner"/>
          <c:xMode val="edge"/>
          <c:yMode val="edge"/>
          <c:x val="0.11547456470637599"/>
          <c:y val="0.11115098729813976"/>
          <c:w val="0.85661309642144634"/>
          <c:h val="0.73922268364667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ealthy 3-4 Measures'!$L$96</c:f>
              <c:strCache>
                <c:ptCount val="1"/>
                <c:pt idx="0">
                  <c:v>D/S</c:v>
                </c:pt>
              </c:strCache>
            </c:strRef>
          </c:tx>
          <c:spPr>
            <a:noFill/>
            <a:ln w="25400" cap="flat" cmpd="sng" algn="ctr">
              <a:solidFill>
                <a:schemeClr val="tx1"/>
              </a:solidFill>
              <a:miter lim="800000"/>
            </a:ln>
            <a:effectLst/>
          </c:spPr>
          <c:invertIfNegative val="0"/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poly"/>
            <c:order val="6"/>
            <c:dispRSqr val="1"/>
            <c:dispEq val="1"/>
            <c:trendlineLbl>
              <c:layout>
                <c:manualLayout>
                  <c:x val="-5.1058891076115484E-2"/>
                  <c:y val="-0.34689304461942255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s-CO"/>
                </a:p>
              </c:txPr>
            </c:trendlineLbl>
          </c:trendline>
          <c:errBars>
            <c:errBarType val="both"/>
            <c:errValType val="cust"/>
            <c:noEndCap val="0"/>
            <c:plus>
              <c:numRef>
                <c:f>'Healthy 3-4 Measures'!$M$97:$V$97</c:f>
                <c:numCache>
                  <c:formatCode>General</c:formatCode>
                  <c:ptCount val="10"/>
                  <c:pt idx="0">
                    <c:v>0.40441525441061194</c:v>
                  </c:pt>
                  <c:pt idx="1">
                    <c:v>0.13285330255586422</c:v>
                  </c:pt>
                  <c:pt idx="2">
                    <c:v>0.22037242719239325</c:v>
                  </c:pt>
                  <c:pt idx="3">
                    <c:v>0.164338952864412</c:v>
                  </c:pt>
                  <c:pt idx="4">
                    <c:v>0.24204844851510909</c:v>
                  </c:pt>
                  <c:pt idx="5">
                    <c:v>0.16063490102892156</c:v>
                  </c:pt>
                  <c:pt idx="6">
                    <c:v>0.33910972518387866</c:v>
                  </c:pt>
                  <c:pt idx="7">
                    <c:v>0.19176735905779169</c:v>
                  </c:pt>
                  <c:pt idx="8">
                    <c:v>0.13308894269121935</c:v>
                  </c:pt>
                  <c:pt idx="9">
                    <c:v>0.2041977277052808</c:v>
                  </c:pt>
                </c:numCache>
              </c:numRef>
            </c:plus>
            <c:minus>
              <c:numRef>
                <c:f>'Healthy 3-4 Measures'!$M$97:$V$97</c:f>
                <c:numCache>
                  <c:formatCode>General</c:formatCode>
                  <c:ptCount val="10"/>
                  <c:pt idx="0">
                    <c:v>0.40441525441061194</c:v>
                  </c:pt>
                  <c:pt idx="1">
                    <c:v>0.13285330255586422</c:v>
                  </c:pt>
                  <c:pt idx="2">
                    <c:v>0.22037242719239325</c:v>
                  </c:pt>
                  <c:pt idx="3">
                    <c:v>0.164338952864412</c:v>
                  </c:pt>
                  <c:pt idx="4">
                    <c:v>0.24204844851510909</c:v>
                  </c:pt>
                  <c:pt idx="5">
                    <c:v>0.16063490102892156</c:v>
                  </c:pt>
                  <c:pt idx="6">
                    <c:v>0.33910972518387866</c:v>
                  </c:pt>
                  <c:pt idx="7">
                    <c:v>0.19176735905779169</c:v>
                  </c:pt>
                  <c:pt idx="8">
                    <c:v>0.13308894269121935</c:v>
                  </c:pt>
                  <c:pt idx="9">
                    <c:v>0.204197727705280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Healthy 3-4 Measures'!$M$96:$V$96</c:f>
              <c:numCache>
                <c:formatCode>General</c:formatCode>
                <c:ptCount val="10"/>
                <c:pt idx="0">
                  <c:v>0.92600000000000005</c:v>
                </c:pt>
                <c:pt idx="1">
                  <c:v>0.28000000000000003</c:v>
                </c:pt>
                <c:pt idx="2">
                  <c:v>0.76829999999999998</c:v>
                </c:pt>
                <c:pt idx="3">
                  <c:v>0.64859999999999995</c:v>
                </c:pt>
                <c:pt idx="4">
                  <c:v>0.84289999999999998</c:v>
                </c:pt>
                <c:pt idx="5">
                  <c:v>0.32140000000000002</c:v>
                </c:pt>
                <c:pt idx="6">
                  <c:v>0.71860000000000002</c:v>
                </c:pt>
                <c:pt idx="7">
                  <c:v>0.67630000000000001</c:v>
                </c:pt>
                <c:pt idx="8">
                  <c:v>0.4783</c:v>
                </c:pt>
                <c:pt idx="9">
                  <c:v>0.597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EED-4BB3-A6D6-A776FAEFB3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35"/>
        <c:axId val="451702792"/>
        <c:axId val="451704104"/>
      </c:barChart>
      <c:catAx>
        <c:axId val="4517027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s-CO" b="1"/>
                  <a:t>Postpartum week</a:t>
                </a:r>
              </a:p>
            </c:rich>
          </c:tx>
          <c:layout>
            <c:manualLayout>
              <c:xMode val="edge"/>
              <c:yMode val="edge"/>
              <c:x val="0.44334744268429993"/>
              <c:y val="0.9128549951656597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s-CO"/>
            </a:p>
          </c:txPr>
        </c:title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CO"/>
          </a:p>
        </c:txPr>
        <c:crossAx val="451704104"/>
        <c:crosses val="autoZero"/>
        <c:auto val="1"/>
        <c:lblAlgn val="ctr"/>
        <c:lblOffset val="100"/>
        <c:noMultiLvlLbl val="0"/>
      </c:catAx>
      <c:valAx>
        <c:axId val="451704104"/>
        <c:scaling>
          <c:orientation val="minMax"/>
        </c:scaling>
        <c:delete val="0"/>
        <c:axPos val="l"/>
        <c:majorGridlines>
          <c:spPr>
            <a:ln w="9525">
              <a:solidFill>
                <a:schemeClr val="tx1">
                  <a:lumMod val="15000"/>
                  <a:lumOff val="85000"/>
                </a:schemeClr>
              </a:solidFill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s-CO" b="1" dirty="0"/>
                  <a:t>D/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s-CO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CO"/>
          </a:p>
        </c:txPr>
        <c:crossAx val="45170279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CO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1" i="0" u="none" strike="noStrike" kern="1200" cap="none" spc="5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b="1" dirty="0"/>
              <a:t>D/S values PUD vs healthy</a:t>
            </a:r>
            <a:r>
              <a:rPr lang="en-US" b="1" baseline="0" dirty="0"/>
              <a:t> cows</a:t>
            </a:r>
            <a:endParaRPr lang="en-US" b="1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1" i="0" u="none" strike="noStrike" kern="1200" cap="none" spc="5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s-CO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Only 3-4Measures PUD vs Health '!$I$161</c:f>
              <c:strCache>
                <c:ptCount val="1"/>
                <c:pt idx="0">
                  <c:v>D/S</c:v>
                </c:pt>
              </c:strCache>
            </c:strRef>
          </c:tx>
          <c:spPr>
            <a:noFill/>
            <a:ln w="25400" cap="flat" cmpd="sng" algn="ctr">
              <a:solidFill>
                <a:schemeClr val="dk1">
                  <a:tint val="88500"/>
                </a:schemeClr>
              </a:solidFill>
              <a:miter lim="800000"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>
                  <a:lumMod val="85000"/>
                </a:sysClr>
              </a:solidFill>
              <a:ln w="25400" cap="flat" cmpd="sng" algn="ctr">
                <a:solidFill>
                  <a:schemeClr val="dk1">
                    <a:tint val="88500"/>
                  </a:schemeClr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2-4B0E-4C31-ADA2-F8FD833A28AD}"/>
              </c:ext>
            </c:extLst>
          </c:dPt>
          <c:dPt>
            <c:idx val="2"/>
            <c:invertIfNegative val="0"/>
            <c:bubble3D val="0"/>
            <c:spPr>
              <a:solidFill>
                <a:sysClr val="window" lastClr="FFFFFF">
                  <a:lumMod val="85000"/>
                </a:sysClr>
              </a:solidFill>
              <a:ln w="25400" cap="flat" cmpd="sng" algn="ctr">
                <a:solidFill>
                  <a:schemeClr val="dk1">
                    <a:tint val="88500"/>
                  </a:schemeClr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3-4B0E-4C31-ADA2-F8FD833A28AD}"/>
              </c:ext>
            </c:extLst>
          </c:dPt>
          <c:dPt>
            <c:idx val="4"/>
            <c:invertIfNegative val="0"/>
            <c:bubble3D val="0"/>
            <c:spPr>
              <a:solidFill>
                <a:sysClr val="window" lastClr="FFFFFF">
                  <a:lumMod val="85000"/>
                </a:sysClr>
              </a:solidFill>
              <a:ln w="25400" cap="flat" cmpd="sng" algn="ctr">
                <a:solidFill>
                  <a:schemeClr val="dk1">
                    <a:tint val="88500"/>
                  </a:schemeClr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4-4B0E-4C31-ADA2-F8FD833A28AD}"/>
              </c:ext>
            </c:extLst>
          </c:dPt>
          <c:errBars>
            <c:errBarType val="both"/>
            <c:errValType val="cust"/>
            <c:noEndCap val="0"/>
            <c:plus>
              <c:numRef>
                <c:f>'Only 3-4Measures PUD vs Health '!$J$162:$O$162</c:f>
                <c:numCache>
                  <c:formatCode>General</c:formatCode>
                  <c:ptCount val="6"/>
                  <c:pt idx="0">
                    <c:v>0.24149534156997729</c:v>
                  </c:pt>
                  <c:pt idx="1">
                    <c:v>0.55500000000000005</c:v>
                  </c:pt>
                  <c:pt idx="2">
                    <c:v>0.41233077336850171</c:v>
                  </c:pt>
                  <c:pt idx="3">
                    <c:v>0.13880441875771346</c:v>
                  </c:pt>
                  <c:pt idx="4">
                    <c:v>0.32500000000000001</c:v>
                  </c:pt>
                  <c:pt idx="5">
                    <c:v>0.36499999999999999</c:v>
                  </c:pt>
                </c:numCache>
              </c:numRef>
            </c:plus>
            <c:minus>
              <c:numRef>
                <c:f>'Only 3-4Measures PUD vs Health '!$J$162:$O$162</c:f>
                <c:numCache>
                  <c:formatCode>General</c:formatCode>
                  <c:ptCount val="6"/>
                  <c:pt idx="0">
                    <c:v>0.24149534156997729</c:v>
                  </c:pt>
                  <c:pt idx="1">
                    <c:v>0.55500000000000005</c:v>
                  </c:pt>
                  <c:pt idx="2">
                    <c:v>0.41233077336850171</c:v>
                  </c:pt>
                  <c:pt idx="3">
                    <c:v>0.13880441875771346</c:v>
                  </c:pt>
                  <c:pt idx="4">
                    <c:v>0.32500000000000001</c:v>
                  </c:pt>
                  <c:pt idx="5">
                    <c:v>0.3649999999999999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Only 3-4Measures PUD vs Health '!$J$152:$O$152</c:f>
              <c:strCache>
                <c:ptCount val="6"/>
                <c:pt idx="0">
                  <c:v>Metritis</c:v>
                </c:pt>
                <c:pt idx="1">
                  <c:v>Healthy paired</c:v>
                </c:pt>
                <c:pt idx="2">
                  <c:v>CE</c:v>
                </c:pt>
                <c:pt idx="3">
                  <c:v>Healthy paired</c:v>
                </c:pt>
                <c:pt idx="4">
                  <c:v>SE</c:v>
                </c:pt>
                <c:pt idx="5">
                  <c:v>Healthy paired</c:v>
                </c:pt>
              </c:strCache>
            </c:strRef>
          </c:cat>
          <c:val>
            <c:numRef>
              <c:f>'Only 3-4Measures PUD vs Health '!$J$161:$O$161</c:f>
              <c:numCache>
                <c:formatCode>#,##0.0</c:formatCode>
                <c:ptCount val="6"/>
                <c:pt idx="0">
                  <c:v>0.93</c:v>
                </c:pt>
                <c:pt idx="1">
                  <c:v>0.78</c:v>
                </c:pt>
                <c:pt idx="2" formatCode="0.00">
                  <c:v>1.31</c:v>
                </c:pt>
                <c:pt idx="3" formatCode="General">
                  <c:v>0.3</c:v>
                </c:pt>
                <c:pt idx="4" formatCode="General">
                  <c:v>0.67</c:v>
                </c:pt>
                <c:pt idx="5" formatCode="General">
                  <c:v>1.10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0E-4C31-ADA2-F8FD833A28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35"/>
        <c:axId val="451557416"/>
        <c:axId val="593452840"/>
      </c:barChart>
      <c:catAx>
        <c:axId val="4515574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s-CO" b="1"/>
                  <a:t>Uterine statu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s-CO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CO"/>
          </a:p>
        </c:txPr>
        <c:crossAx val="593452840"/>
        <c:crosses val="autoZero"/>
        <c:auto val="1"/>
        <c:lblAlgn val="ctr"/>
        <c:lblOffset val="100"/>
        <c:noMultiLvlLbl val="0"/>
      </c:catAx>
      <c:valAx>
        <c:axId val="593452840"/>
        <c:scaling>
          <c:orientation val="minMax"/>
        </c:scaling>
        <c:delete val="0"/>
        <c:axPos val="l"/>
        <c:majorGridlines>
          <c:spPr>
            <a:ln w="9525">
              <a:solidFill>
                <a:schemeClr val="tx1">
                  <a:lumMod val="15000"/>
                  <a:lumOff val="85000"/>
                </a:schemeClr>
              </a:solidFill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s-CO" b="1" dirty="0"/>
                  <a:t>D/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s-CO"/>
            </a:p>
          </c:txPr>
        </c:title>
        <c:numFmt formatCode="#,##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CO"/>
          </a:p>
        </c:txPr>
        <c:crossAx val="451557416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4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s-CO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1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35000"/>
          <a:lumOff val="65000"/>
        </a:schemeClr>
      </a:solidFill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/>
    <cs:effectRef idx="0"/>
    <cs:fontRef idx="minor">
      <a:schemeClr val="dk1"/>
    </cs:fontRef>
    <cs:spPr>
      <a:noFill/>
      <a:ln w="25400" cap="flat" cmpd="sng" algn="ctr">
        <a:solidFill>
          <a:schemeClr val="phClr"/>
        </a:solidFill>
        <a:miter lim="800000"/>
      </a:ln>
    </cs:spPr>
  </cs:dataPoint>
  <cs:dataPoint3D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flat" cmpd="sng" algn="ctr">
        <a:solidFill>
          <a:schemeClr val="phClr"/>
        </a:solidFill>
        <a:miter lim="800000"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1"/>
    <cs:effectRef idx="0"/>
    <cs:fontRef idx="minor">
      <a:schemeClr val="tx1"/>
    </cs:fontRef>
    <cs:spPr>
      <a:ln w="9525">
        <a:solidFill>
          <a:schemeClr val="phClr"/>
        </a:solidFill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00" b="0" kern="1200" cap="none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11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35000"/>
          <a:lumOff val="65000"/>
        </a:schemeClr>
      </a:solidFill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/>
    <cs:effectRef idx="0"/>
    <cs:fontRef idx="minor">
      <a:schemeClr val="dk1"/>
    </cs:fontRef>
    <cs:spPr>
      <a:noFill/>
      <a:ln w="25400" cap="flat" cmpd="sng" algn="ctr">
        <a:solidFill>
          <a:schemeClr val="phClr"/>
        </a:solidFill>
        <a:miter lim="800000"/>
      </a:ln>
    </cs:spPr>
  </cs:dataPoint>
  <cs:dataPoint3D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flat" cmpd="sng" algn="ctr">
        <a:solidFill>
          <a:schemeClr val="phClr"/>
        </a:solidFill>
        <a:miter lim="800000"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1"/>
    <cs:effectRef idx="0"/>
    <cs:fontRef idx="minor">
      <a:schemeClr val="tx1"/>
    </cs:fontRef>
    <cs:spPr>
      <a:ln w="9525">
        <a:solidFill>
          <a:schemeClr val="phClr"/>
        </a:solidFill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00" b="0" kern="1200" cap="none" spc="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BB3D7E-1F3E-4852-9C99-C8D4B3272E78}" type="datetimeFigureOut">
              <a:rPr lang="es-CO" smtClean="0"/>
              <a:t>8/11/2022</a:t>
            </a:fld>
            <a:endParaRPr lang="es-CO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3028950" y="857250"/>
            <a:ext cx="30861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O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189C20-9A67-405A-9210-23FB25F186CF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495834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CBCC4F-3540-49F3-87ED-7A230A717DA6}" type="datetime1">
              <a:rPr lang="es-CO" smtClean="0"/>
              <a:t>8/11/2022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70376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B1690-B7AA-4B57-BA6D-B8F0319E3CDB}" type="datetime1">
              <a:rPr lang="es-CO" smtClean="0"/>
              <a:t>8/11/2022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310329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DD268-0E0E-40BE-A448-8AE8745DD5BB}" type="datetime1">
              <a:rPr lang="es-CO" smtClean="0"/>
              <a:t>8/11/2022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048712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91E0-CA52-4BC0-BBAC-841582474171}" type="datetime1">
              <a:rPr lang="es-CO" smtClean="0"/>
              <a:t>8/11/2022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53194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A0385-C385-437B-BCE7-550FE8CDD087}" type="datetime1">
              <a:rPr lang="es-CO" smtClean="0"/>
              <a:t>8/11/2022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9638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BA85EC-BD2B-4299-908C-687046D9B26D}" type="datetime1">
              <a:rPr lang="es-CO" smtClean="0"/>
              <a:t>8/11/2022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06453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75A9EB-861C-4698-8448-2D4E71CEFCD1}" type="datetime1">
              <a:rPr lang="es-CO" smtClean="0"/>
              <a:t>8/11/2022</a:t>
            </a:fld>
            <a:endParaRPr lang="es-C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998099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6CA30-D278-4FCB-90BB-9C622B4124FB}" type="datetime1">
              <a:rPr lang="es-CO" smtClean="0"/>
              <a:t>8/11/2022</a:t>
            </a:fld>
            <a:endParaRPr lang="es-C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56227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D2C11-960D-4630-B412-74A5B2DA9FDD}" type="datetime1">
              <a:rPr lang="es-CO" smtClean="0"/>
              <a:t>8/11/2022</a:t>
            </a:fld>
            <a:endParaRPr lang="es-C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887762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23E0E-C96D-491F-BAF5-60749BD404BB}" type="datetime1">
              <a:rPr lang="es-CO" smtClean="0"/>
              <a:t>8/11/2022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085020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0DB16-6C17-4DBC-BFAC-AC1032B6110E}" type="datetime1">
              <a:rPr lang="es-CO" smtClean="0"/>
              <a:t>8/11/2022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057799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47CB6C-F6F0-4740-A2CA-79EC0B6E6C09}" type="datetime1">
              <a:rPr lang="es-CO" smtClean="0"/>
              <a:t>8/11/2022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pt-BR"/>
              <a:t>Cronograma de actividades fase IA</a:t>
            </a:r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B9526-AFF0-46D9-810B-E5724A9DF8E4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628558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sldNum="0" hdr="0" dt="0"/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Flecha derecha 39"/>
          <p:cNvSpPr/>
          <p:nvPr/>
        </p:nvSpPr>
        <p:spPr>
          <a:xfrm rot="16487078" flipH="1">
            <a:off x="14169326" y="-1951859"/>
            <a:ext cx="274907" cy="646338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4267">
              <a:solidFill>
                <a:schemeClr val="tx1"/>
              </a:solidFill>
            </a:endParaRPr>
          </a:p>
        </p:txBody>
      </p:sp>
      <p:sp>
        <p:nvSpPr>
          <p:cNvPr id="13" name="Rectángulo 12"/>
          <p:cNvSpPr/>
          <p:nvPr/>
        </p:nvSpPr>
        <p:spPr>
          <a:xfrm>
            <a:off x="1759099" y="-3555998"/>
            <a:ext cx="580608" cy="7489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42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s-CO" sz="4267" dirty="0"/>
          </a:p>
        </p:txBody>
      </p:sp>
      <p:sp>
        <p:nvSpPr>
          <p:cNvPr id="20" name="Rectángulo 19">
            <a:extLst>
              <a:ext uri="{FF2B5EF4-FFF2-40B4-BE49-F238E27FC236}">
                <a16:creationId xmlns:a16="http://schemas.microsoft.com/office/drawing/2014/main" id="{6507672C-4AE7-42C2-B32E-7055A9DA4B1D}"/>
              </a:ext>
            </a:extLst>
          </p:cNvPr>
          <p:cNvSpPr/>
          <p:nvPr/>
        </p:nvSpPr>
        <p:spPr>
          <a:xfrm>
            <a:off x="3525" y="0"/>
            <a:ext cx="481222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s-CO" sz="3200" dirty="0"/>
          </a:p>
        </p:txBody>
      </p:sp>
      <p:sp>
        <p:nvSpPr>
          <p:cNvPr id="21" name="Rectángulo 20">
            <a:extLst>
              <a:ext uri="{FF2B5EF4-FFF2-40B4-BE49-F238E27FC236}">
                <a16:creationId xmlns:a16="http://schemas.microsoft.com/office/drawing/2014/main" id="{469F2A2F-3488-4DB1-A617-78B5DD048293}"/>
              </a:ext>
            </a:extLst>
          </p:cNvPr>
          <p:cNvSpPr/>
          <p:nvPr/>
        </p:nvSpPr>
        <p:spPr>
          <a:xfrm>
            <a:off x="6096000" y="0"/>
            <a:ext cx="458780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s-CO" sz="3200" dirty="0"/>
          </a:p>
        </p:txBody>
      </p:sp>
      <p:graphicFrame>
        <p:nvGraphicFramePr>
          <p:cNvPr id="25" name="Gráfico 24">
            <a:extLst>
              <a:ext uri="{FF2B5EF4-FFF2-40B4-BE49-F238E27FC236}">
                <a16:creationId xmlns:a16="http://schemas.microsoft.com/office/drawing/2014/main" id="{65A927C4-D238-4C81-8529-7D53222817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2393954"/>
              </p:ext>
            </p:extLst>
          </p:nvPr>
        </p:nvGraphicFramePr>
        <p:xfrm>
          <a:off x="0" y="0"/>
          <a:ext cx="6096000" cy="45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6" name="Gráfico 25">
            <a:extLst>
              <a:ext uri="{FF2B5EF4-FFF2-40B4-BE49-F238E27FC236}">
                <a16:creationId xmlns:a16="http://schemas.microsoft.com/office/drawing/2014/main" id="{D3061A86-F8E8-439C-83C7-B2166EB5E5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4235782"/>
              </p:ext>
            </p:extLst>
          </p:nvPr>
        </p:nvGraphicFramePr>
        <p:xfrm>
          <a:off x="6096000" y="0"/>
          <a:ext cx="5976395" cy="45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1710212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Tema de Office">
    <a:dk1>
      <a:srgbClr val="000000"/>
    </a:dk1>
    <a:lt1>
      <a:srgbClr val="FFFFFF"/>
    </a:lt1>
    <a:dk2>
      <a:srgbClr val="A7A7A7"/>
    </a:dk2>
    <a:lt2>
      <a:srgbClr val="535353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FF00FF"/>
    </a:folHlink>
  </a:clrScheme>
  <a:fontScheme name="Tema de Office">
    <a:majorFont>
      <a:latin typeface="Helvetica Neue"/>
      <a:ea typeface="Helvetica Neue"/>
      <a:cs typeface="Helvetica Neue"/>
    </a:majorFont>
    <a:minorFont>
      <a:latin typeface="Helvetica Neue"/>
      <a:ea typeface="Helvetica Neue"/>
      <a:cs typeface="Helvetica Neue"/>
    </a:minorFont>
  </a:fontScheme>
  <a:fmtScheme name="Tema de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29999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4999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381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381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38100" dist="20000" dir="5400000" rotWithShape="0">
            <a:srgbClr val="000000">
              <a:alpha val="38000"/>
            </a:srgbClr>
          </a:outerShdw>
        </a:effectLst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Tema de Office">
    <a:dk1>
      <a:srgbClr val="000000"/>
    </a:dk1>
    <a:lt1>
      <a:srgbClr val="FFFFFF"/>
    </a:lt1>
    <a:dk2>
      <a:srgbClr val="A7A7A7"/>
    </a:dk2>
    <a:lt2>
      <a:srgbClr val="535353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FF00FF"/>
    </a:folHlink>
  </a:clrScheme>
  <a:fontScheme name="Tema de Office">
    <a:majorFont>
      <a:latin typeface="Helvetica Neue"/>
      <a:ea typeface="Helvetica Neue"/>
      <a:cs typeface="Helvetica Neue"/>
    </a:majorFont>
    <a:minorFont>
      <a:latin typeface="Helvetica Neue"/>
      <a:ea typeface="Helvetica Neue"/>
      <a:cs typeface="Helvetica Neue"/>
    </a:minorFont>
  </a:fontScheme>
  <a:fmtScheme name="Tema de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29999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4999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381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381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38100" dist="20000" dir="5400000" rotWithShape="0">
            <a:srgbClr val="000000">
              <a:alpha val="38000"/>
            </a:srgbClr>
          </a:outerShdw>
        </a:effectLst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2</TotalTime>
  <Words>19</Words>
  <Application>Microsoft Office PowerPoint</Application>
  <PresentationFormat>Personalizado</PresentationFormat>
  <Paragraphs>9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indows User</dc:creator>
  <cp:lastModifiedBy>Usuario de Windows</cp:lastModifiedBy>
  <cp:revision>92</cp:revision>
  <dcterms:created xsi:type="dcterms:W3CDTF">2017-04-20T12:24:30Z</dcterms:created>
  <dcterms:modified xsi:type="dcterms:W3CDTF">2022-11-08T16:19:43Z</dcterms:modified>
</cp:coreProperties>
</file>